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96" r:id="rId2"/>
    <p:sldId id="300" r:id="rId3"/>
    <p:sldId id="297" r:id="rId4"/>
    <p:sldId id="298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944" autoAdjust="0"/>
    <p:restoredTop sz="94774"/>
  </p:normalViewPr>
  <p:slideViewPr>
    <p:cSldViewPr snapToGrid="0">
      <p:cViewPr>
        <p:scale>
          <a:sx n="100" d="100"/>
          <a:sy n="100" d="100"/>
        </p:scale>
        <p:origin x="3456" y="3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2938F-FA33-4953-B61B-31E456AF4595}" type="datetimeFigureOut">
              <a:rPr lang="zh-CN" altLang="en-US" smtClean="0"/>
              <a:t>2025/9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644D73-5371-40A9-95D1-F901CD1372A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2938F-FA33-4953-B61B-31E456AF4595}" type="datetimeFigureOut">
              <a:rPr lang="zh-CN" altLang="en-US" smtClean="0"/>
              <a:t>2025/9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644D73-5371-40A9-95D1-F901CD1372A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2938F-FA33-4953-B61B-31E456AF4595}" type="datetimeFigureOut">
              <a:rPr lang="zh-CN" altLang="en-US" smtClean="0"/>
              <a:t>2025/9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644D73-5371-40A9-95D1-F901CD1372A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2938F-FA33-4953-B61B-31E456AF4595}" type="datetimeFigureOut">
              <a:rPr lang="zh-CN" altLang="en-US" smtClean="0"/>
              <a:t>2025/9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644D73-5371-40A9-95D1-F901CD1372A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2938F-FA33-4953-B61B-31E456AF4595}" type="datetimeFigureOut">
              <a:rPr lang="zh-CN" altLang="en-US" smtClean="0"/>
              <a:t>2025/9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644D73-5371-40A9-95D1-F901CD1372A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2938F-FA33-4953-B61B-31E456AF4595}" type="datetimeFigureOut">
              <a:rPr lang="zh-CN" altLang="en-US" smtClean="0"/>
              <a:t>2025/9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644D73-5371-40A9-95D1-F901CD1372A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2938F-FA33-4953-B61B-31E456AF4595}" type="datetimeFigureOut">
              <a:rPr lang="zh-CN" altLang="en-US" smtClean="0"/>
              <a:t>2025/9/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644D73-5371-40A9-95D1-F901CD1372A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2938F-FA33-4953-B61B-31E456AF4595}" type="datetimeFigureOut">
              <a:rPr lang="zh-CN" altLang="en-US" smtClean="0"/>
              <a:t>2025/9/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644D73-5371-40A9-95D1-F901CD1372A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2938F-FA33-4953-B61B-31E456AF4595}" type="datetimeFigureOut">
              <a:rPr lang="zh-CN" altLang="en-US" smtClean="0"/>
              <a:t>2025/9/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644D73-5371-40A9-95D1-F901CD1372A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2938F-FA33-4953-B61B-31E456AF4595}" type="datetimeFigureOut">
              <a:rPr lang="zh-CN" altLang="en-US" smtClean="0"/>
              <a:t>2025/9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644D73-5371-40A9-95D1-F901CD1372A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2938F-FA33-4953-B61B-31E456AF4595}" type="datetimeFigureOut">
              <a:rPr lang="zh-CN" altLang="en-US" smtClean="0"/>
              <a:t>2025/9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644D73-5371-40A9-95D1-F901CD1372A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A2938F-FA33-4953-B61B-31E456AF4595}" type="datetimeFigureOut">
              <a:rPr lang="zh-CN" altLang="en-US" smtClean="0"/>
              <a:t>2025/9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644D73-5371-40A9-95D1-F901CD1372A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9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583411C6-D375-F8B6-4645-C89F5AD3442A}"/>
              </a:ext>
            </a:extLst>
          </p:cNvPr>
          <p:cNvSpPr txBox="1"/>
          <p:nvPr/>
        </p:nvSpPr>
        <p:spPr>
          <a:xfrm>
            <a:off x="0" y="5511071"/>
            <a:ext cx="6858000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1.</a:t>
            </a:r>
            <a:r>
              <a: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SE" sz="1200" b="1" dirty="0">
                <a:latin typeface="Arial" panose="020B0604020202020204" pitchFamily="34" charset="0"/>
                <a:cs typeface="Arial" panose="020B0604020202020204" pitchFamily="34" charset="0"/>
              </a:rPr>
              <a:t>Soluble salivary gland proteins (SGPs) from </a:t>
            </a:r>
            <a:r>
              <a:rPr lang="en-SE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Aedes aegypti </a:t>
            </a:r>
            <a:r>
              <a:rPr lang="en-SE" sz="1200" b="1" dirty="0">
                <a:latin typeface="Arial" panose="020B0604020202020204" pitchFamily="34" charset="0"/>
                <a:cs typeface="Arial" panose="020B0604020202020204" pitchFamily="34" charset="0"/>
              </a:rPr>
              <a:t>induce mast cell degranulation</a:t>
            </a:r>
            <a:r>
              <a:rPr lang="en-SE" sz="1200" dirty="0">
                <a:latin typeface="Arial" panose="020B0604020202020204" pitchFamily="34" charset="0"/>
                <a:cs typeface="Arial" panose="020B0604020202020204" pitchFamily="34" charset="0"/>
              </a:rPr>
              <a:t>. BMMCs were stimulated with 1, 10, or 100 ng/mL SGPs from Ae. aegypti for 6 hours. Lipopolysaccharide (LPS) served as a positive control. β-hexosaminidase activity was measured to assess degranulation. Data represent means ± SEM.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s,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ot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gnificant,</a:t>
            </a:r>
            <a:r>
              <a:rPr lang="en-SE" sz="1200" dirty="0">
                <a:latin typeface="Arial" panose="020B0604020202020204" pitchFamily="34" charset="0"/>
                <a:cs typeface="Arial" panose="020B0604020202020204" pitchFamily="34" charset="0"/>
              </a:rPr>
              <a:t> *p &lt; 0.05, ***p &lt; 0.001 , ***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SE" sz="1200" dirty="0">
                <a:latin typeface="Arial" panose="020B0604020202020204" pitchFamily="34" charset="0"/>
                <a:cs typeface="Arial" panose="020B0604020202020204" pitchFamily="34" charset="0"/>
              </a:rPr>
              <a:t>p &lt; 0.00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en-SE" sz="1200" dirty="0">
                <a:latin typeface="Arial" panose="020B0604020202020204" pitchFamily="34" charset="0"/>
                <a:cs typeface="Arial" panose="020B0604020202020204" pitchFamily="34" charset="0"/>
              </a:rPr>
              <a:t>1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BEFD220A-B4A1-4004-00C2-8EAEEDD55E2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960117" y="2465544"/>
            <a:ext cx="2645709" cy="28257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825611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D125E607-3962-9E2F-89BD-7E47EB523828}"/>
              </a:ext>
            </a:extLst>
          </p:cNvPr>
          <p:cNvSpPr txBox="1"/>
          <p:nvPr/>
        </p:nvSpPr>
        <p:spPr>
          <a:xfrm>
            <a:off x="0" y="5511071"/>
            <a:ext cx="6858000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</a:t>
            </a:r>
            <a:r>
              <a: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2.</a:t>
            </a:r>
            <a:r>
              <a: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hromogenic substrate assay confirms recombinant mMCP-4 activity. </a:t>
            </a:r>
            <a:r>
              <a:rPr lang="en-SE" sz="1200" dirty="0">
                <a:latin typeface="Arial" panose="020B0604020202020204" pitchFamily="34" charset="0"/>
                <a:cs typeface="Arial" panose="020B0604020202020204" pitchFamily="34" charset="0"/>
              </a:rPr>
              <a:t>To verify the enzymatic activity of recombinant mMCP-4, 10 ng of enzyme was dissolved in 100 µl sterile PBS (0.15 M NaCl) in the presence or absence of 10 ng of the chymase inhibitor Fulacimstat (#HY-109059, MedChemExpress). At room temperature, 20 µl of the chromogenic chymase substrate L-1595 (2.5 mM) was added to each well. Optical density (OD) was recorded at 405 nm at 0, 10, 20, 30, and 60 min. </a:t>
            </a:r>
          </a:p>
          <a:p>
            <a:pPr algn="just"/>
            <a:endParaRPr lang="en-S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26">
            <a:extLst>
              <a:ext uri="{FF2B5EF4-FFF2-40B4-BE49-F238E27FC236}">
                <a16:creationId xmlns:a16="http://schemas.microsoft.com/office/drawing/2014/main" id="{F8C99F56-079A-0959-9A51-48A874878F29}"/>
              </a:ext>
            </a:extLst>
          </p:cNvPr>
          <p:cNvSpPr txBox="1"/>
          <p:nvPr/>
        </p:nvSpPr>
        <p:spPr>
          <a:xfrm>
            <a:off x="0" y="1301220"/>
            <a:ext cx="206654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altLang="zh-CN" sz="1200" b="1" dirty="0">
                <a:latin typeface="Arial" panose="020B0604020202090204" pitchFamily="34" charset="0"/>
                <a:cs typeface="Arial" panose="020B0604020202090204" pitchFamily="34" charset="0"/>
              </a:rPr>
              <a:t>Supplementary Figure</a:t>
            </a:r>
            <a:r>
              <a:rPr lang="zh-CN" altLang="en-US" sz="1200" b="1" dirty="0">
                <a:latin typeface="Arial" panose="020B0604020202090204" pitchFamily="34" charset="0"/>
                <a:cs typeface="Arial" panose="020B0604020202090204" pitchFamily="34" charset="0"/>
              </a:rPr>
              <a:t> </a:t>
            </a:r>
            <a:r>
              <a:rPr lang="en-US" altLang="zh-CN" sz="1200" b="1" dirty="0">
                <a:latin typeface="Arial" panose="020B0604020202090204" pitchFamily="34" charset="0"/>
                <a:cs typeface="Arial" panose="020B0604020202090204" pitchFamily="34" charset="0"/>
              </a:rPr>
              <a:t>2</a:t>
            </a:r>
            <a:endParaRPr lang="en-US" altLang="zh-CN" sz="12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0A6FC963-341D-027D-1DB6-C9B1BB4E37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31111" y="2353446"/>
            <a:ext cx="2795778" cy="29195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410078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0E746F55-9A2B-1C3F-423D-9CF809454BC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24034343"/>
              </p:ext>
            </p:extLst>
          </p:nvPr>
        </p:nvGraphicFramePr>
        <p:xfrm>
          <a:off x="338329" y="2692876"/>
          <a:ext cx="6135623" cy="3830746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987551">
                  <a:extLst>
                    <a:ext uri="{9D8B030D-6E8A-4147-A177-3AD203B41FA5}">
                      <a16:colId xmlns:a16="http://schemas.microsoft.com/office/drawing/2014/main" val="3427526766"/>
                    </a:ext>
                  </a:extLst>
                </a:gridCol>
                <a:gridCol w="2734056">
                  <a:extLst>
                    <a:ext uri="{9D8B030D-6E8A-4147-A177-3AD203B41FA5}">
                      <a16:colId xmlns:a16="http://schemas.microsoft.com/office/drawing/2014/main" val="2006653695"/>
                    </a:ext>
                  </a:extLst>
                </a:gridCol>
                <a:gridCol w="1664208">
                  <a:extLst>
                    <a:ext uri="{9D8B030D-6E8A-4147-A177-3AD203B41FA5}">
                      <a16:colId xmlns:a16="http://schemas.microsoft.com/office/drawing/2014/main" val="1105739619"/>
                    </a:ext>
                  </a:extLst>
                </a:gridCol>
                <a:gridCol w="749808">
                  <a:extLst>
                    <a:ext uri="{9D8B030D-6E8A-4147-A177-3AD203B41FA5}">
                      <a16:colId xmlns:a16="http://schemas.microsoft.com/office/drawing/2014/main" val="2931123549"/>
                    </a:ext>
                  </a:extLst>
                </a:gridCol>
              </a:tblGrid>
              <a:tr h="50752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ession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scription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5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FDR Confidence: Combined</a:t>
                      </a:r>
                      <a:endParaRPr lang="en-GB" sz="105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W [</a:t>
                      </a:r>
                      <a:r>
                        <a:rPr lang="en-GB" sz="1050" b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a</a:t>
                      </a:r>
                      <a:r>
                        <a:rPr lang="en-GB" sz="105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extLst>
                  <a:ext uri="{0D108BD9-81ED-4DB2-BD59-A6C34878D82A}">
                    <a16:rowId xmlns:a16="http://schemas.microsoft.com/office/drawing/2014/main" val="625771247"/>
                  </a:ext>
                </a:extLst>
              </a:tr>
              <a:tr h="237373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9HYM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yceraldehyde-3-phosphate dehydrogenase 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E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.4</a:t>
                      </a:r>
                      <a:endParaRPr lang="en-S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extLst>
                  <a:ext uri="{0D108BD9-81ED-4DB2-BD59-A6C34878D82A}">
                    <a16:rowId xmlns:a16="http://schemas.microsoft.com/office/drawing/2014/main" val="1611816113"/>
                  </a:ext>
                </a:extLst>
              </a:tr>
              <a:tr h="237373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0A6I8T5F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ycerol-3-phosphate dehydrogenase [NAD(+)]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E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.6</a:t>
                      </a:r>
                      <a:endParaRPr lang="en-S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extLst>
                  <a:ext uri="{0D108BD9-81ED-4DB2-BD59-A6C34878D82A}">
                    <a16:rowId xmlns:a16="http://schemas.microsoft.com/office/drawing/2014/main" val="1468710935"/>
                  </a:ext>
                </a:extLst>
              </a:tr>
              <a:tr h="237373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0A1S4FHF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ate dehydrogenas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E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.7</a:t>
                      </a:r>
                      <a:endParaRPr lang="en-S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extLst>
                  <a:ext uri="{0D108BD9-81ED-4DB2-BD59-A6C34878D82A}">
                    <a16:rowId xmlns:a16="http://schemas.microsoft.com/office/drawing/2014/main" val="996167844"/>
                  </a:ext>
                </a:extLst>
              </a:tr>
              <a:tr h="237373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17MF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EL001022-PB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E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.7</a:t>
                      </a:r>
                      <a:endParaRPr lang="en-S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extLst>
                  <a:ext uri="{0D108BD9-81ED-4DB2-BD59-A6C34878D82A}">
                    <a16:rowId xmlns:a16="http://schemas.microsoft.com/office/drawing/2014/main" val="1486005960"/>
                  </a:ext>
                </a:extLst>
              </a:tr>
              <a:tr h="237373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0A0P6IVD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doreflexin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E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.7</a:t>
                      </a:r>
                      <a:endParaRPr lang="en-S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extLst>
                  <a:ext uri="{0D108BD9-81ED-4DB2-BD59-A6C34878D82A}">
                    <a16:rowId xmlns:a16="http://schemas.microsoft.com/office/drawing/2014/main" val="294513133"/>
                  </a:ext>
                </a:extLst>
              </a:tr>
              <a:tr h="237373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1815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en-GB" sz="1000" b="1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Long form salivary protein D7L1</a:t>
                      </a:r>
                    </a:p>
                  </a:txBody>
                  <a:tcPr marL="3399" marR="3399" marT="33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E" sz="10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.9</a:t>
                      </a:r>
                      <a:endParaRPr lang="en-S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extLst>
                  <a:ext uri="{0D108BD9-81ED-4DB2-BD59-A6C34878D82A}">
                    <a16:rowId xmlns:a16="http://schemas.microsoft.com/office/drawing/2014/main" val="2757319191"/>
                  </a:ext>
                </a:extLst>
              </a:tr>
              <a:tr h="237373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17IG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EL002362-P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E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.5</a:t>
                      </a:r>
                      <a:endParaRPr lang="en-S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extLst>
                  <a:ext uri="{0D108BD9-81ED-4DB2-BD59-A6C34878D82A}">
                    <a16:rowId xmlns:a16="http://schemas.microsoft.com/office/drawing/2014/main" val="2296788140"/>
                  </a:ext>
                </a:extLst>
              </a:tr>
              <a:tr h="237373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16K9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ine/threonine-protein phosphatas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E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.5</a:t>
                      </a:r>
                      <a:endParaRPr lang="en-S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extLst>
                  <a:ext uri="{0D108BD9-81ED-4DB2-BD59-A6C34878D82A}">
                    <a16:rowId xmlns:a16="http://schemas.microsoft.com/office/drawing/2014/main" val="2202218061"/>
                  </a:ext>
                </a:extLst>
              </a:tr>
              <a:tr h="237373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0A1S4G1F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lybdopterin cofactor sulfurase (</a:t>
                      </a:r>
                      <a:r>
                        <a:rPr lang="en-GB" sz="1000" b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sc</a:t>
                      </a:r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E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.5</a:t>
                      </a:r>
                      <a:endParaRPr lang="en-S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extLst>
                  <a:ext uri="{0D108BD9-81ED-4DB2-BD59-A6C34878D82A}">
                    <a16:rowId xmlns:a16="http://schemas.microsoft.com/office/drawing/2014/main" val="3504498149"/>
                  </a:ext>
                </a:extLst>
              </a:tr>
              <a:tr h="237373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0A6I8U64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characterized protein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E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.4</a:t>
                      </a:r>
                      <a:endParaRPr lang="en-S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extLst>
                  <a:ext uri="{0D108BD9-81ED-4DB2-BD59-A6C34878D82A}">
                    <a16:rowId xmlns:a16="http://schemas.microsoft.com/office/drawing/2014/main" val="3397348727"/>
                  </a:ext>
                </a:extLst>
              </a:tr>
              <a:tr h="237373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1HQJ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doreflexin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E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.4</a:t>
                      </a:r>
                      <a:endParaRPr lang="en-S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extLst>
                  <a:ext uri="{0D108BD9-81ED-4DB2-BD59-A6C34878D82A}">
                    <a16:rowId xmlns:a16="http://schemas.microsoft.com/office/drawing/2014/main" val="3339965837"/>
                  </a:ext>
                </a:extLst>
              </a:tr>
              <a:tr h="237373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1HQM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EL003634-P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E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.9</a:t>
                      </a:r>
                      <a:endParaRPr lang="en-S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extLst>
                  <a:ext uri="{0D108BD9-81ED-4DB2-BD59-A6C34878D82A}">
                    <a16:rowId xmlns:a16="http://schemas.microsoft.com/office/drawing/2014/main" val="1822794805"/>
                  </a:ext>
                </a:extLst>
              </a:tr>
              <a:tr h="237373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16ND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lactate dehydrogenas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E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.5</a:t>
                      </a:r>
                      <a:endParaRPr lang="en-S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extLst>
                  <a:ext uri="{0D108BD9-81ED-4DB2-BD59-A6C34878D82A}">
                    <a16:rowId xmlns:a16="http://schemas.microsoft.com/office/drawing/2014/main" val="3756856207"/>
                  </a:ext>
                </a:extLst>
              </a:tr>
              <a:tr h="237373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95V9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ng form D7Bclu1 salivary protein</a:t>
                      </a:r>
                      <a:endParaRPr lang="en-GB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E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.6</a:t>
                      </a:r>
                      <a:endParaRPr lang="en-S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399" marR="3399" marT="3399" marB="0" anchor="ctr"/>
                </a:tc>
                <a:extLst>
                  <a:ext uri="{0D108BD9-81ED-4DB2-BD59-A6C34878D82A}">
                    <a16:rowId xmlns:a16="http://schemas.microsoft.com/office/drawing/2014/main" val="534315917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5DC97014-0DB5-F656-1052-DCCC59693BF9}"/>
              </a:ext>
            </a:extLst>
          </p:cNvPr>
          <p:cNvSpPr txBox="1"/>
          <p:nvPr/>
        </p:nvSpPr>
        <p:spPr>
          <a:xfrm>
            <a:off x="109390" y="2263247"/>
            <a:ext cx="622249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I</a:t>
            </a:r>
            <a:r>
              <a:rPr lang="en-GB" sz="1200" b="1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dentified</a:t>
            </a:r>
            <a:r>
              <a:rPr lang="en-GB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SE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Aedes aegypti </a:t>
            </a:r>
            <a:r>
              <a:rPr lang="en-SE" sz="1200" b="1" dirty="0">
                <a:latin typeface="Arial" panose="020B0604020202020204" pitchFamily="34" charset="0"/>
                <a:cs typeface="Arial" panose="020B0604020202020204" pitchFamily="34" charset="0"/>
              </a:rPr>
              <a:t>SGPs</a:t>
            </a:r>
            <a:r>
              <a:rPr lang="en-GB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that possibly can be cleaved by </a:t>
            </a:r>
            <a:r>
              <a:rPr lang="en-US" altLang="zh-CN" sz="1200" b="1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hymase</a:t>
            </a:r>
            <a:r>
              <a:rPr lang="zh-CN" altLang="en-US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mMCP-4</a:t>
            </a:r>
            <a:r>
              <a:rPr lang="en-GB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  <a:endParaRPr lang="en-GB" sz="105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8" name="文本框 26">
            <a:extLst>
              <a:ext uri="{FF2B5EF4-FFF2-40B4-BE49-F238E27FC236}">
                <a16:creationId xmlns:a16="http://schemas.microsoft.com/office/drawing/2014/main" id="{B0B74957-FB74-8B61-8F14-F1D8E2B08BF7}"/>
              </a:ext>
            </a:extLst>
          </p:cNvPr>
          <p:cNvSpPr txBox="1"/>
          <p:nvPr/>
        </p:nvSpPr>
        <p:spPr>
          <a:xfrm>
            <a:off x="0" y="1566396"/>
            <a:ext cx="190195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altLang="zh-CN" sz="1200" b="1" dirty="0">
                <a:latin typeface="Arial" panose="020B0604020202090204" pitchFamily="34" charset="0"/>
                <a:cs typeface="Arial" panose="020B0604020202090204" pitchFamily="34" charset="0"/>
              </a:rPr>
              <a:t>Supplementary Table</a:t>
            </a:r>
            <a:r>
              <a:rPr lang="zh-CN" altLang="en-US" sz="1200" b="1" dirty="0">
                <a:latin typeface="Arial" panose="020B0604020202090204" pitchFamily="34" charset="0"/>
                <a:cs typeface="Arial" panose="020B0604020202090204" pitchFamily="34" charset="0"/>
              </a:rPr>
              <a:t> </a:t>
            </a:r>
            <a:r>
              <a:rPr lang="en-US" altLang="zh-CN" sz="1200" b="1" dirty="0">
                <a:latin typeface="Arial" panose="020B0604020202090204" pitchFamily="34" charset="0"/>
                <a:cs typeface="Arial" panose="020B0604020202090204" pitchFamily="34" charset="0"/>
              </a:rPr>
              <a:t>1</a:t>
            </a:r>
            <a:endParaRPr lang="en-US" altLang="zh-CN" sz="12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843688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FF0B37-4764-1F48-9086-F72478A33D5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35496" y="2331931"/>
            <a:ext cx="5915024" cy="2425427"/>
          </a:xfrm>
        </p:spPr>
        <p:txBody>
          <a:bodyPr>
            <a:normAutofit/>
          </a:bodyPr>
          <a:lstStyle/>
          <a:p>
            <a:pPr marL="0" indent="0" algn="just">
              <a:buNone/>
            </a:pP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MKLPLLLAIV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TTFSVVASTG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PFDPEEMLFT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FTRCMEDNLE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342900" indent="-342900" algn="just">
              <a:buAutoNum type="arabicPlain" startAt="41"/>
            </a:pP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DGPNRLPM</a:t>
            </a:r>
            <a:r>
              <a:rPr lang="en-GB" sz="1400" dirty="0">
                <a:highlight>
                  <a:srgbClr val="C0C0C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zh-CN" altLang="en-US" sz="1400" dirty="0">
                <a:highlight>
                  <a:srgbClr val="C0C0C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dirty="0">
                <a:highlight>
                  <a:srgbClr val="C0C0C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KWKEWI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NEPV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DSPATQCFGK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CVLVRTGLYD</a:t>
            </a:r>
          </a:p>
          <a:p>
            <a:pPr marL="342900" indent="-342900" algn="just">
              <a:buAutoNum type="arabicPlain" startAt="81"/>
            </a:pP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PVAQKFDASV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IQEQFKAYPS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LGEKSKVEAY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ANAVQQLPST</a:t>
            </a:r>
          </a:p>
          <a:p>
            <a:pPr marL="0" indent="0" algn="just">
              <a:buNone/>
            </a:pP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21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NNKGLYEDCA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AVFKAYDPVH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KAHKDTSKNL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FHGNKELTKL</a:t>
            </a:r>
          </a:p>
          <a:p>
            <a:pPr marL="0" indent="0" algn="just">
              <a:buNone/>
            </a:pP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61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GKDIRQK</a:t>
            </a:r>
            <a:r>
              <a:rPr lang="en-GB" sz="1400" dirty="0">
                <a:highlight>
                  <a:srgbClr val="C0C0C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KQS</a:t>
            </a:r>
            <a:r>
              <a:rPr lang="zh-CN" altLang="en-US" sz="1400" dirty="0">
                <a:highlight>
                  <a:srgbClr val="C0C0C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dirty="0">
                <a:highlight>
                  <a:srgbClr val="C0C0C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YFEFCENK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YY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PAGSDKRQQL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CKIRQYTVLD</a:t>
            </a:r>
          </a:p>
          <a:p>
            <a:pPr marL="0" indent="0" algn="just">
              <a:buNone/>
            </a:pP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201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DALFKEHTDC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VMKGIRYITK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NNELDAEEVK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RDFMQVNKDT</a:t>
            </a:r>
          </a:p>
          <a:p>
            <a:pPr marL="0" indent="0" algn="just">
              <a:buNone/>
            </a:pP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241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KALEKVLNDC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KSKEPSNAGE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KSWHYYKCLV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ESSV</a:t>
            </a:r>
            <a:r>
              <a:rPr lang="en-GB" sz="1400" dirty="0">
                <a:highlight>
                  <a:srgbClr val="C0C0C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KDDFKE</a:t>
            </a:r>
          </a:p>
          <a:p>
            <a:pPr marL="0" indent="0" algn="just">
              <a:buNone/>
            </a:pP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281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1400" dirty="0">
                <a:highlight>
                  <a:srgbClr val="C0C0C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AFDYREVR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SQ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IYAFNLPKKQ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VYSKPAVQSQ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VMEIDGKQCP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  <a:endParaRPr lang="en-S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570C1ED-E5A0-4E38-7923-AB24F325A5A4}"/>
              </a:ext>
            </a:extLst>
          </p:cNvPr>
          <p:cNvSpPr txBox="1"/>
          <p:nvPr/>
        </p:nvSpPr>
        <p:spPr>
          <a:xfrm>
            <a:off x="0" y="5511071"/>
            <a:ext cx="685800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</a:t>
            </a:r>
            <a:r>
              <a: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3.</a:t>
            </a:r>
            <a:r>
              <a: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SE" sz="1200" i="1" dirty="0">
                <a:latin typeface="Arial" panose="020B0604020202020204" pitchFamily="34" charset="0"/>
                <a:cs typeface="Arial" panose="020B0604020202020204" pitchFamily="34" charset="0"/>
              </a:rPr>
              <a:t>Aedes aegypti</a:t>
            </a:r>
            <a:r>
              <a:rPr lang="zh-CN" alt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alivary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en-S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zh-CN" alt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ccession</a:t>
            </a:r>
            <a:r>
              <a:rPr lang="zh-CN" alt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.</a:t>
            </a:r>
            <a:r>
              <a:rPr lang="zh-CN" alt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18153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SE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ontain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ve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chymase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target sites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marked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yellow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olor)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. The physiologic target sites for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chymase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is eight amino acids long (P4, P3, P2, P1, P1’, P2’, P3’, P4’).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Chymase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preferentially cuts after aromatic amino F, W or Y located in the P1 position and requires D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or E in the P2’ position. </a:t>
            </a:r>
          </a:p>
          <a:p>
            <a:pPr algn="just"/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S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26">
            <a:extLst>
              <a:ext uri="{FF2B5EF4-FFF2-40B4-BE49-F238E27FC236}">
                <a16:creationId xmlns:a16="http://schemas.microsoft.com/office/drawing/2014/main" id="{54B4FE08-FA6B-7190-0194-A5FF917DC675}"/>
              </a:ext>
            </a:extLst>
          </p:cNvPr>
          <p:cNvSpPr txBox="1"/>
          <p:nvPr/>
        </p:nvSpPr>
        <p:spPr>
          <a:xfrm>
            <a:off x="0" y="1301220"/>
            <a:ext cx="206654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altLang="zh-CN" sz="1200" b="1" dirty="0">
                <a:latin typeface="Arial" panose="020B0604020202090204" pitchFamily="34" charset="0"/>
                <a:cs typeface="Arial" panose="020B0604020202090204" pitchFamily="34" charset="0"/>
              </a:rPr>
              <a:t>Supplementary Figure</a:t>
            </a:r>
            <a:r>
              <a:rPr lang="zh-CN" altLang="en-US" sz="1200" b="1" dirty="0">
                <a:latin typeface="Arial" panose="020B0604020202090204" pitchFamily="34" charset="0"/>
                <a:cs typeface="Arial" panose="020B0604020202090204" pitchFamily="34" charset="0"/>
              </a:rPr>
              <a:t> </a:t>
            </a:r>
            <a:r>
              <a:rPr lang="en-US" altLang="zh-CN" sz="1200" b="1" dirty="0">
                <a:latin typeface="Arial" panose="020B0604020202090204" pitchFamily="34" charset="0"/>
                <a:cs typeface="Arial" panose="020B0604020202090204" pitchFamily="34" charset="0"/>
              </a:rPr>
              <a:t>3</a:t>
            </a:r>
            <a:endParaRPr lang="en-US" altLang="zh-CN" sz="12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60058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832</TotalTime>
  <Words>427</Words>
  <Application>Microsoft Macintosh PowerPoint</Application>
  <PresentationFormat>A4 Paper (210x297 mm)</PresentationFormat>
  <Paragraphs>75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等线</vt:lpstr>
      <vt:lpstr>Arial</vt:lpstr>
      <vt:lpstr>Calibri</vt:lpstr>
      <vt:lpstr>Calibri Light</vt:lpstr>
      <vt:lpstr>Office 主题​​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 Zhiqiang</dc:creator>
  <cp:lastModifiedBy>Zhiqiang Li</cp:lastModifiedBy>
  <cp:revision>38</cp:revision>
  <dcterms:created xsi:type="dcterms:W3CDTF">2025-04-17T11:11:02Z</dcterms:created>
  <dcterms:modified xsi:type="dcterms:W3CDTF">2025-09-07T19:00:4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B76ACF9B55FD7C14C6E1006843A4E91C_43</vt:lpwstr>
  </property>
  <property fmtid="{D5CDD505-2E9C-101B-9397-08002B2CF9AE}" pid="3" name="KSOProductBuildVer">
    <vt:lpwstr>2052-7.3.1.8967</vt:lpwstr>
  </property>
</Properties>
</file>